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wmf" ContentType="image/x-w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wmf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s-E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</p:showPr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8" d="100"/>
          <a:sy n="118" d="100"/>
        </p:scale>
        <p:origin x="-12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G:\ChSNP\Island\ChSNP25x48827-ROH-Het-ASD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G:\ChSNP\Island\ChSNP25x48827-ROH-Het-ASD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s-ES"/>
  <c:chart>
    <c:title>
      <c:tx>
        <c:rich>
          <a:bodyPr/>
          <a:lstStyle/>
          <a:p>
            <a:pPr>
              <a:defRPr sz="1200" b="0"/>
            </a:pPr>
            <a:r>
              <a:rPr lang="nl-NL" sz="1200" b="0"/>
              <a:t>r</a:t>
            </a:r>
            <a:r>
              <a:rPr lang="nl-NL" sz="1200" b="0" baseline="30000"/>
              <a:t>2</a:t>
            </a:r>
            <a:r>
              <a:rPr lang="nl-NL" sz="1200" b="0"/>
              <a:t>=0.956</a:t>
            </a:r>
          </a:p>
        </c:rich>
      </c:tx>
      <c:layout>
        <c:manualLayout>
          <c:xMode val="edge"/>
          <c:yMode val="edge"/>
          <c:x val="0.24743367079115131"/>
          <c:y val="0.13529442643199044"/>
        </c:manualLayout>
      </c:layout>
    </c:title>
    <c:plotArea>
      <c:layout>
        <c:manualLayout>
          <c:layoutTarget val="inner"/>
          <c:xMode val="edge"/>
          <c:yMode val="edge"/>
          <c:x val="0.24574175702784645"/>
          <c:y val="0.11198733981781681"/>
          <c:w val="0.66005939257592861"/>
          <c:h val="0.66092141423498607"/>
        </c:manualLayout>
      </c:layout>
      <c:scatterChart>
        <c:scatterStyle val="lineMarker"/>
        <c:ser>
          <c:idx val="0"/>
          <c:order val="0"/>
          <c:tx>
            <c:strRef>
              <c:f>'Ho-intraASD-FROH'!$E$60</c:f>
              <c:strCache>
                <c:ptCount val="1"/>
                <c:pt idx="0">
                  <c:v>Island</c:v>
                </c:pt>
              </c:strCache>
            </c:strRef>
          </c:tx>
          <c:spPr>
            <a:ln w="28575">
              <a:noFill/>
            </a:ln>
          </c:spPr>
          <c:marker>
            <c:symbol val="plus"/>
            <c:size val="7"/>
            <c:spPr>
              <a:ln w="15875">
                <a:solidFill>
                  <a:srgbClr val="FF0000"/>
                </a:solidFill>
              </a:ln>
            </c:spPr>
          </c:marker>
          <c:xVal>
            <c:numRef>
              <c:f>'Ho-intraASD-FROH'!$D$61:$D$85</c:f>
              <c:numCache>
                <c:formatCode>General</c:formatCode>
                <c:ptCount val="25"/>
                <c:pt idx="0">
                  <c:v>0.13501229268042061</c:v>
                </c:pt>
                <c:pt idx="1">
                  <c:v>0.35667789025266888</c:v>
                </c:pt>
                <c:pt idx="2">
                  <c:v>0.35996200000000039</c:v>
                </c:pt>
                <c:pt idx="3">
                  <c:v>0.32683294998126189</c:v>
                </c:pt>
                <c:pt idx="4">
                  <c:v>0.34638415963299962</c:v>
                </c:pt>
                <c:pt idx="5">
                  <c:v>0.29447658564112161</c:v>
                </c:pt>
                <c:pt idx="6">
                  <c:v>0.33477954683696481</c:v>
                </c:pt>
                <c:pt idx="7">
                  <c:v>0.38829771443471889</c:v>
                </c:pt>
                <c:pt idx="8">
                  <c:v>0.39408259354910641</c:v>
                </c:pt>
                <c:pt idx="9">
                  <c:v>0.39759494372372567</c:v>
                </c:pt>
                <c:pt idx="10">
                  <c:v>0.41380549554471541</c:v>
                </c:pt>
                <c:pt idx="11">
                  <c:v>0.35868617107633677</c:v>
                </c:pt>
                <c:pt idx="12">
                  <c:v>0.39699473599044777</c:v>
                </c:pt>
                <c:pt idx="13">
                  <c:v>0.39963908791745839</c:v>
                </c:pt>
                <c:pt idx="14">
                  <c:v>0.37775734446918863</c:v>
                </c:pt>
                <c:pt idx="15">
                  <c:v>0.36084015521063095</c:v>
                </c:pt>
                <c:pt idx="16">
                  <c:v>0.37485645348417945</c:v>
                </c:pt>
                <c:pt idx="17">
                  <c:v>0.38286303334590077</c:v>
                </c:pt>
                <c:pt idx="18">
                  <c:v>0.27737569490767516</c:v>
                </c:pt>
                <c:pt idx="19">
                  <c:v>0.3939039069854039</c:v>
                </c:pt>
                <c:pt idx="20">
                  <c:v>0.28104852571080235</c:v>
                </c:pt>
                <c:pt idx="21">
                  <c:v>0.24278978225705444</c:v>
                </c:pt>
                <c:pt idx="22">
                  <c:v>0.25676178777038861</c:v>
                </c:pt>
                <c:pt idx="23">
                  <c:v>0.30712615947685717</c:v>
                </c:pt>
                <c:pt idx="24">
                  <c:v>0.3245195319846696</c:v>
                </c:pt>
              </c:numCache>
            </c:numRef>
          </c:xVal>
          <c:yVal>
            <c:numRef>
              <c:f>'Ho-intraASD-FROH'!$E$61:$E$85</c:f>
              <c:numCache>
                <c:formatCode>General</c:formatCode>
                <c:ptCount val="25"/>
                <c:pt idx="0">
                  <c:v>0.13376679090909091</c:v>
                </c:pt>
                <c:pt idx="4">
                  <c:v>0.27355644166666682</c:v>
                </c:pt>
                <c:pt idx="5">
                  <c:v>0.24778728571428602</c:v>
                </c:pt>
                <c:pt idx="6">
                  <c:v>0.26634808888888922</c:v>
                </c:pt>
                <c:pt idx="18">
                  <c:v>0.24533243809523844</c:v>
                </c:pt>
                <c:pt idx="20">
                  <c:v>0.27567260439560515</c:v>
                </c:pt>
                <c:pt idx="21">
                  <c:v>0.24172241125541133</c:v>
                </c:pt>
                <c:pt idx="22">
                  <c:v>0.23600406432748541</c:v>
                </c:pt>
                <c:pt idx="23">
                  <c:v>0.29511881868131878</c:v>
                </c:pt>
                <c:pt idx="24">
                  <c:v>0.28445313333333339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0-1208-44B0-926D-9FD78455B642}"/>
            </c:ext>
          </c:extLst>
        </c:ser>
        <c:ser>
          <c:idx val="1"/>
          <c:order val="1"/>
          <c:tx>
            <c:strRef>
              <c:f>'Ho-intraASD-FROH'!$F$60</c:f>
              <c:strCache>
                <c:ptCount val="1"/>
                <c:pt idx="0">
                  <c:v>Mediterranean Island</c:v>
                </c:pt>
              </c:strCache>
            </c:strRef>
          </c:tx>
          <c:spPr>
            <a:ln w="28575">
              <a:noFill/>
            </a:ln>
          </c:spPr>
          <c:marker>
            <c:symbol val="plus"/>
            <c:size val="7"/>
            <c:spPr>
              <a:ln w="15875">
                <a:solidFill>
                  <a:srgbClr val="3399FF"/>
                </a:solidFill>
              </a:ln>
            </c:spPr>
          </c:marker>
          <c:xVal>
            <c:numRef>
              <c:f>'Ho-intraASD-FROH'!$D$61:$D$85</c:f>
              <c:numCache>
                <c:formatCode>General</c:formatCode>
                <c:ptCount val="25"/>
                <c:pt idx="0">
                  <c:v>0.13501229268042061</c:v>
                </c:pt>
                <c:pt idx="1">
                  <c:v>0.35667789025266888</c:v>
                </c:pt>
                <c:pt idx="2">
                  <c:v>0.35996200000000039</c:v>
                </c:pt>
                <c:pt idx="3">
                  <c:v>0.32683294998126189</c:v>
                </c:pt>
                <c:pt idx="4">
                  <c:v>0.34638415963299962</c:v>
                </c:pt>
                <c:pt idx="5">
                  <c:v>0.29447658564112161</c:v>
                </c:pt>
                <c:pt idx="6">
                  <c:v>0.33477954683696481</c:v>
                </c:pt>
                <c:pt idx="7">
                  <c:v>0.38829771443471889</c:v>
                </c:pt>
                <c:pt idx="8">
                  <c:v>0.39408259354910641</c:v>
                </c:pt>
                <c:pt idx="9">
                  <c:v>0.39759494372372567</c:v>
                </c:pt>
                <c:pt idx="10">
                  <c:v>0.41380549554471541</c:v>
                </c:pt>
                <c:pt idx="11">
                  <c:v>0.35868617107633677</c:v>
                </c:pt>
                <c:pt idx="12">
                  <c:v>0.39699473599044777</c:v>
                </c:pt>
                <c:pt idx="13">
                  <c:v>0.39963908791745839</c:v>
                </c:pt>
                <c:pt idx="14">
                  <c:v>0.37775734446918863</c:v>
                </c:pt>
                <c:pt idx="15">
                  <c:v>0.36084015521063095</c:v>
                </c:pt>
                <c:pt idx="16">
                  <c:v>0.37485645348417945</c:v>
                </c:pt>
                <c:pt idx="17">
                  <c:v>0.38286303334590077</c:v>
                </c:pt>
                <c:pt idx="18">
                  <c:v>0.27737569490767516</c:v>
                </c:pt>
                <c:pt idx="19">
                  <c:v>0.3939039069854039</c:v>
                </c:pt>
                <c:pt idx="20">
                  <c:v>0.28104852571080235</c:v>
                </c:pt>
                <c:pt idx="21">
                  <c:v>0.24278978225705444</c:v>
                </c:pt>
                <c:pt idx="22">
                  <c:v>0.25676178777038861</c:v>
                </c:pt>
                <c:pt idx="23">
                  <c:v>0.30712615947685717</c:v>
                </c:pt>
                <c:pt idx="24">
                  <c:v>0.3245195319846696</c:v>
                </c:pt>
              </c:numCache>
            </c:numRef>
          </c:xVal>
          <c:yVal>
            <c:numRef>
              <c:f>'Ho-intraASD-FROH'!$F$61:$F$85</c:f>
              <c:numCache>
                <c:formatCode>General</c:formatCode>
                <c:ptCount val="25"/>
                <c:pt idx="10">
                  <c:v>0.33891927536231969</c:v>
                </c:pt>
                <c:pt idx="11">
                  <c:v>0.30395869927536306</c:v>
                </c:pt>
                <c:pt idx="12">
                  <c:v>0.33447035467980379</c:v>
                </c:pt>
                <c:pt idx="13">
                  <c:v>0.33894745584045638</c:v>
                </c:pt>
                <c:pt idx="14">
                  <c:v>0.30973893939393937</c:v>
                </c:pt>
                <c:pt idx="15">
                  <c:v>0.31998788888888968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1-1208-44B0-926D-9FD78455B642}"/>
            </c:ext>
          </c:extLst>
        </c:ser>
        <c:ser>
          <c:idx val="2"/>
          <c:order val="2"/>
          <c:tx>
            <c:strRef>
              <c:f>'Ho-intraASD-FROH'!$G$60</c:f>
              <c:strCache>
                <c:ptCount val="1"/>
                <c:pt idx="0">
                  <c:v>Nordic</c:v>
                </c:pt>
              </c:strCache>
            </c:strRef>
          </c:tx>
          <c:spPr>
            <a:ln w="28575">
              <a:noFill/>
            </a:ln>
          </c:spPr>
          <c:marker>
            <c:symbol val="x"/>
            <c:size val="7"/>
            <c:spPr>
              <a:noFill/>
              <a:ln w="15875">
                <a:solidFill>
                  <a:srgbClr val="0000FF"/>
                </a:solidFill>
              </a:ln>
            </c:spPr>
          </c:marker>
          <c:xVal>
            <c:numRef>
              <c:f>'Ho-intraASD-FROH'!$D$61:$D$85</c:f>
              <c:numCache>
                <c:formatCode>General</c:formatCode>
                <c:ptCount val="25"/>
                <c:pt idx="0">
                  <c:v>0.13501229268042061</c:v>
                </c:pt>
                <c:pt idx="1">
                  <c:v>0.35667789025266888</c:v>
                </c:pt>
                <c:pt idx="2">
                  <c:v>0.35996200000000039</c:v>
                </c:pt>
                <c:pt idx="3">
                  <c:v>0.32683294998126189</c:v>
                </c:pt>
                <c:pt idx="4">
                  <c:v>0.34638415963299962</c:v>
                </c:pt>
                <c:pt idx="5">
                  <c:v>0.29447658564112161</c:v>
                </c:pt>
                <c:pt idx="6">
                  <c:v>0.33477954683696481</c:v>
                </c:pt>
                <c:pt idx="7">
                  <c:v>0.38829771443471889</c:v>
                </c:pt>
                <c:pt idx="8">
                  <c:v>0.39408259354910641</c:v>
                </c:pt>
                <c:pt idx="9">
                  <c:v>0.39759494372372567</c:v>
                </c:pt>
                <c:pt idx="10">
                  <c:v>0.41380549554471541</c:v>
                </c:pt>
                <c:pt idx="11">
                  <c:v>0.35868617107633677</c:v>
                </c:pt>
                <c:pt idx="12">
                  <c:v>0.39699473599044777</c:v>
                </c:pt>
                <c:pt idx="13">
                  <c:v>0.39963908791745839</c:v>
                </c:pt>
                <c:pt idx="14">
                  <c:v>0.37775734446918863</c:v>
                </c:pt>
                <c:pt idx="15">
                  <c:v>0.36084015521063095</c:v>
                </c:pt>
                <c:pt idx="16">
                  <c:v>0.37485645348417945</c:v>
                </c:pt>
                <c:pt idx="17">
                  <c:v>0.38286303334590077</c:v>
                </c:pt>
                <c:pt idx="18">
                  <c:v>0.27737569490767516</c:v>
                </c:pt>
                <c:pt idx="19">
                  <c:v>0.3939039069854039</c:v>
                </c:pt>
                <c:pt idx="20">
                  <c:v>0.28104852571080235</c:v>
                </c:pt>
                <c:pt idx="21">
                  <c:v>0.24278978225705444</c:v>
                </c:pt>
                <c:pt idx="22">
                  <c:v>0.25676178777038861</c:v>
                </c:pt>
                <c:pt idx="23">
                  <c:v>0.30712615947685717</c:v>
                </c:pt>
                <c:pt idx="24">
                  <c:v>0.3245195319846696</c:v>
                </c:pt>
              </c:numCache>
            </c:numRef>
          </c:xVal>
          <c:yVal>
            <c:numRef>
              <c:f>'Ho-intraASD-FROH'!$G$61:$G$85</c:f>
              <c:numCache>
                <c:formatCode>General</c:formatCode>
                <c:ptCount val="25"/>
                <c:pt idx="1">
                  <c:v>0.30291224736842165</c:v>
                </c:pt>
                <c:pt idx="2">
                  <c:v>0.32173648571428598</c:v>
                </c:pt>
                <c:pt idx="3">
                  <c:v>0.26224602857142815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2-1208-44B0-926D-9FD78455B642}"/>
            </c:ext>
          </c:extLst>
        </c:ser>
        <c:ser>
          <c:idx val="3"/>
          <c:order val="3"/>
          <c:tx>
            <c:strRef>
              <c:f>'Ho-intraASD-FROH'!$H$60</c:f>
              <c:strCache>
                <c:ptCount val="1"/>
                <c:pt idx="0">
                  <c:v>Continental</c:v>
                </c:pt>
              </c:strCache>
            </c:strRef>
          </c:tx>
          <c:spPr>
            <a:ln w="28575">
              <a:noFill/>
            </a:ln>
          </c:spPr>
          <c:marker>
            <c:symbol val="x"/>
            <c:size val="6"/>
            <c:spPr>
              <a:noFill/>
              <a:ln w="15875">
                <a:solidFill>
                  <a:srgbClr val="FF7C80"/>
                </a:solidFill>
              </a:ln>
            </c:spPr>
          </c:marker>
          <c:xVal>
            <c:numRef>
              <c:f>'Ho-intraASD-FROH'!$D$61:$D$85</c:f>
              <c:numCache>
                <c:formatCode>General</c:formatCode>
                <c:ptCount val="25"/>
                <c:pt idx="0">
                  <c:v>0.13501229268042061</c:v>
                </c:pt>
                <c:pt idx="1">
                  <c:v>0.35667789025266888</c:v>
                </c:pt>
                <c:pt idx="2">
                  <c:v>0.35996200000000039</c:v>
                </c:pt>
                <c:pt idx="3">
                  <c:v>0.32683294998126189</c:v>
                </c:pt>
                <c:pt idx="4">
                  <c:v>0.34638415963299962</c:v>
                </c:pt>
                <c:pt idx="5">
                  <c:v>0.29447658564112161</c:v>
                </c:pt>
                <c:pt idx="6">
                  <c:v>0.33477954683696481</c:v>
                </c:pt>
                <c:pt idx="7">
                  <c:v>0.38829771443471889</c:v>
                </c:pt>
                <c:pt idx="8">
                  <c:v>0.39408259354910641</c:v>
                </c:pt>
                <c:pt idx="9">
                  <c:v>0.39759494372372567</c:v>
                </c:pt>
                <c:pt idx="10">
                  <c:v>0.41380549554471541</c:v>
                </c:pt>
                <c:pt idx="11">
                  <c:v>0.35868617107633677</c:v>
                </c:pt>
                <c:pt idx="12">
                  <c:v>0.39699473599044777</c:v>
                </c:pt>
                <c:pt idx="13">
                  <c:v>0.39963908791745839</c:v>
                </c:pt>
                <c:pt idx="14">
                  <c:v>0.37775734446918863</c:v>
                </c:pt>
                <c:pt idx="15">
                  <c:v>0.36084015521063095</c:v>
                </c:pt>
                <c:pt idx="16">
                  <c:v>0.37485645348417945</c:v>
                </c:pt>
                <c:pt idx="17">
                  <c:v>0.38286303334590077</c:v>
                </c:pt>
                <c:pt idx="18">
                  <c:v>0.27737569490767516</c:v>
                </c:pt>
                <c:pt idx="19">
                  <c:v>0.3939039069854039</c:v>
                </c:pt>
                <c:pt idx="20">
                  <c:v>0.28104852571080235</c:v>
                </c:pt>
                <c:pt idx="21">
                  <c:v>0.24278978225705444</c:v>
                </c:pt>
                <c:pt idx="22">
                  <c:v>0.25676178777038861</c:v>
                </c:pt>
                <c:pt idx="23">
                  <c:v>0.30712615947685717</c:v>
                </c:pt>
                <c:pt idx="24">
                  <c:v>0.3245195319846696</c:v>
                </c:pt>
              </c:numCache>
            </c:numRef>
          </c:xVal>
          <c:yVal>
            <c:numRef>
              <c:f>'Ho-intraASD-FROH'!$H$61:$H$85</c:f>
              <c:numCache>
                <c:formatCode>General</c:formatCode>
                <c:ptCount val="25"/>
                <c:pt idx="7">
                  <c:v>0.32890712318840626</c:v>
                </c:pt>
                <c:pt idx="8">
                  <c:v>0.34362125000000004</c:v>
                </c:pt>
                <c:pt idx="9">
                  <c:v>0.33835695652173936</c:v>
                </c:pt>
                <c:pt idx="16">
                  <c:v>0.32481702105263238</c:v>
                </c:pt>
                <c:pt idx="17">
                  <c:v>0.34935210666666688</c:v>
                </c:pt>
                <c:pt idx="19">
                  <c:v>0.32536819480519552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3-1208-44B0-926D-9FD78455B642}"/>
            </c:ext>
          </c:extLst>
        </c:ser>
        <c:axId val="85616512"/>
        <c:axId val="53764480"/>
      </c:scatterChart>
      <c:valAx>
        <c:axId val="85616512"/>
        <c:scaling>
          <c:orientation val="minMax"/>
          <c:min val="0.1"/>
        </c:scaling>
        <c:axPos val="b"/>
        <c:title>
          <c:tx>
            <c:rich>
              <a:bodyPr/>
              <a:lstStyle/>
              <a:p>
                <a:pPr>
                  <a:defRPr sz="1200" b="0" baseline="0"/>
                </a:pPr>
                <a:r>
                  <a:rPr lang="nl-NL" sz="1200" b="0" baseline="0"/>
                  <a:t>Observed heterozygosity</a:t>
                </a:r>
              </a:p>
            </c:rich>
          </c:tx>
        </c:title>
        <c:numFmt formatCode="General" sourceLinked="1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 baseline="0"/>
            </a:pPr>
            <a:endParaRPr lang="es-ES"/>
          </a:p>
        </c:txPr>
        <c:crossAx val="53764480"/>
        <c:crosses val="autoZero"/>
        <c:crossBetween val="midCat"/>
        <c:majorUnit val="0.1"/>
      </c:valAx>
      <c:valAx>
        <c:axId val="53764480"/>
        <c:scaling>
          <c:orientation val="minMax"/>
          <c:max val="0.4"/>
          <c:min val="0.1"/>
        </c:scaling>
        <c:axPos val="l"/>
        <c:majorGridlines>
          <c:spPr>
            <a:ln>
              <a:noFill/>
            </a:ln>
          </c:spPr>
        </c:majorGridlines>
        <c:title>
          <c:tx>
            <c:rich>
              <a:bodyPr/>
              <a:lstStyle/>
              <a:p>
                <a:pPr>
                  <a:defRPr sz="1200" b="0" baseline="0"/>
                </a:pPr>
                <a:r>
                  <a:rPr lang="nl-NL" sz="1200" b="0" baseline="0"/>
                  <a:t>Within-population   ASD</a:t>
                </a:r>
              </a:p>
            </c:rich>
          </c:tx>
        </c:title>
        <c:numFmt formatCode="General" sourceLinked="1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 baseline="0"/>
            </a:pPr>
            <a:endParaRPr lang="es-ES"/>
          </a:p>
        </c:txPr>
        <c:crossAx val="85616512"/>
        <c:crosses val="autoZero"/>
        <c:crossBetween val="midCat"/>
      </c:valAx>
      <c:spPr>
        <a:ln>
          <a:solidFill>
            <a:schemeClr val="tx1"/>
          </a:solidFill>
        </a:ln>
      </c:spPr>
    </c:plotArea>
    <c:legend>
      <c:legendPos val="r"/>
      <c:layout>
        <c:manualLayout>
          <c:xMode val="edge"/>
          <c:yMode val="edge"/>
          <c:x val="0.42103027427069906"/>
          <c:y val="0.53582417213822764"/>
          <c:w val="0.46560024263312372"/>
          <c:h val="0.23617672790901112"/>
        </c:manualLayout>
      </c:layout>
      <c:spPr>
        <a:ln>
          <a:solidFill>
            <a:schemeClr val="tx1"/>
          </a:solidFill>
        </a:ln>
      </c:spPr>
      <c:txPr>
        <a:bodyPr/>
        <a:lstStyle/>
        <a:p>
          <a:pPr>
            <a:defRPr sz="1050" baseline="0"/>
          </a:pPr>
          <a:endParaRPr lang="es-ES"/>
        </a:p>
      </c:txPr>
    </c:legend>
    <c:plotVisOnly val="1"/>
    <c:dispBlanksAs val="gap"/>
  </c:chart>
  <c:spPr>
    <a:ln>
      <a:noFill/>
    </a:ln>
  </c:sp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s-ES"/>
  <c:chart>
    <c:title>
      <c:tx>
        <c:rich>
          <a:bodyPr/>
          <a:lstStyle/>
          <a:p>
            <a:pPr>
              <a:defRPr sz="1200" b="0"/>
            </a:pPr>
            <a:r>
              <a:rPr lang="nl-NL" sz="1200" b="0" dirty="0"/>
              <a:t>r</a:t>
            </a:r>
            <a:r>
              <a:rPr lang="nl-NL" sz="1200" b="0" baseline="30000" dirty="0"/>
              <a:t>2</a:t>
            </a:r>
            <a:r>
              <a:rPr lang="nl-NL" sz="1200" b="0" dirty="0"/>
              <a:t>=0.976</a:t>
            </a:r>
          </a:p>
        </c:rich>
      </c:tx>
      <c:layout>
        <c:manualLayout>
          <c:xMode val="edge"/>
          <c:yMode val="edge"/>
          <c:x val="0.63209199576949404"/>
          <c:y val="0.29872221243910008"/>
        </c:manualLayout>
      </c:layout>
    </c:title>
    <c:plotArea>
      <c:layout>
        <c:manualLayout>
          <c:layoutTarget val="inner"/>
          <c:xMode val="edge"/>
          <c:yMode val="edge"/>
          <c:x val="0.24574175702784645"/>
          <c:y val="5.5794990482419808E-2"/>
          <c:w val="0.55133243211025651"/>
          <c:h val="0.71711403486704739"/>
        </c:manualLayout>
      </c:layout>
      <c:scatterChart>
        <c:scatterStyle val="lineMarker"/>
        <c:ser>
          <c:idx val="0"/>
          <c:order val="0"/>
          <c:tx>
            <c:strRef>
              <c:f>'Ho-intraASD-FROH'!$E$88</c:f>
              <c:strCache>
                <c:ptCount val="1"/>
                <c:pt idx="0">
                  <c:v>Island</c:v>
                </c:pt>
              </c:strCache>
            </c:strRef>
          </c:tx>
          <c:spPr>
            <a:ln w="28575">
              <a:noFill/>
            </a:ln>
          </c:spPr>
          <c:marker>
            <c:symbol val="plus"/>
            <c:size val="7"/>
            <c:spPr>
              <a:ln w="15875">
                <a:solidFill>
                  <a:srgbClr val="FF0000"/>
                </a:solidFill>
              </a:ln>
            </c:spPr>
          </c:marker>
          <c:xVal>
            <c:numRef>
              <c:f>'Ho-intraASD-FROH'!$D$89:$D$113</c:f>
              <c:numCache>
                <c:formatCode>General</c:formatCode>
                <c:ptCount val="25"/>
                <c:pt idx="0">
                  <c:v>0.13501229268042061</c:v>
                </c:pt>
                <c:pt idx="1">
                  <c:v>0.35667789025266888</c:v>
                </c:pt>
                <c:pt idx="2">
                  <c:v>0.35996200000000039</c:v>
                </c:pt>
                <c:pt idx="3">
                  <c:v>0.32683294998126189</c:v>
                </c:pt>
                <c:pt idx="4">
                  <c:v>0.34638415963299962</c:v>
                </c:pt>
                <c:pt idx="5">
                  <c:v>0.29447658564112161</c:v>
                </c:pt>
                <c:pt idx="6">
                  <c:v>0.33477954683696481</c:v>
                </c:pt>
                <c:pt idx="7">
                  <c:v>0.38829771443471889</c:v>
                </c:pt>
                <c:pt idx="8">
                  <c:v>0.39408259354910641</c:v>
                </c:pt>
                <c:pt idx="9">
                  <c:v>0.39759494372372567</c:v>
                </c:pt>
                <c:pt idx="10">
                  <c:v>0.41380549554471541</c:v>
                </c:pt>
                <c:pt idx="11">
                  <c:v>0.35868617107633677</c:v>
                </c:pt>
                <c:pt idx="12">
                  <c:v>0.39699473599044777</c:v>
                </c:pt>
                <c:pt idx="13">
                  <c:v>0.39963908791745839</c:v>
                </c:pt>
                <c:pt idx="14">
                  <c:v>0.37775734446918863</c:v>
                </c:pt>
                <c:pt idx="15">
                  <c:v>0.36084015521063095</c:v>
                </c:pt>
                <c:pt idx="16">
                  <c:v>0.37485645348417945</c:v>
                </c:pt>
                <c:pt idx="17">
                  <c:v>0.38286303334590077</c:v>
                </c:pt>
                <c:pt idx="18">
                  <c:v>0.27737569490767516</c:v>
                </c:pt>
                <c:pt idx="19">
                  <c:v>0.3939039069854039</c:v>
                </c:pt>
                <c:pt idx="20">
                  <c:v>0.28104852571080235</c:v>
                </c:pt>
                <c:pt idx="21">
                  <c:v>0.24278978225705444</c:v>
                </c:pt>
                <c:pt idx="22">
                  <c:v>0.25676178777038861</c:v>
                </c:pt>
                <c:pt idx="23">
                  <c:v>0.30712615947685717</c:v>
                </c:pt>
                <c:pt idx="24">
                  <c:v>0.3245195319846696</c:v>
                </c:pt>
              </c:numCache>
            </c:numRef>
          </c:xVal>
          <c:yVal>
            <c:numRef>
              <c:f>'Ho-intraASD-FROH'!$E$89:$E$113</c:f>
              <c:numCache>
                <c:formatCode>General</c:formatCode>
                <c:ptCount val="25"/>
                <c:pt idx="0" formatCode="00,000">
                  <c:v>0.66255954495433245</c:v>
                </c:pt>
                <c:pt idx="4" formatCode="00,000">
                  <c:v>0.13165594660688815</c:v>
                </c:pt>
                <c:pt idx="5" formatCode="00,000">
                  <c:v>0.29901372941715931</c:v>
                </c:pt>
                <c:pt idx="6" formatCode="00,000">
                  <c:v>0.21735545331159586</c:v>
                </c:pt>
                <c:pt idx="18" formatCode="00,000">
                  <c:v>0.23305410189525183</c:v>
                </c:pt>
                <c:pt idx="20" formatCode="00,000">
                  <c:v>0.25957591647500661</c:v>
                </c:pt>
                <c:pt idx="21" formatCode="00,000">
                  <c:v>0.34838864879485804</c:v>
                </c:pt>
                <c:pt idx="22" formatCode="00,000">
                  <c:v>0.32498710701146644</c:v>
                </c:pt>
                <c:pt idx="23" formatCode="00,000">
                  <c:v>0.23017340314856327</c:v>
                </c:pt>
                <c:pt idx="24" formatCode="00,000">
                  <c:v>0.19500407832348338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0-6B6B-4D59-B74E-EF2D32C92F04}"/>
            </c:ext>
          </c:extLst>
        </c:ser>
        <c:ser>
          <c:idx val="1"/>
          <c:order val="1"/>
          <c:tx>
            <c:strRef>
              <c:f>'Ho-intraASD-FROH'!$F$88</c:f>
              <c:strCache>
                <c:ptCount val="1"/>
                <c:pt idx="0">
                  <c:v>Mediterranean Island</c:v>
                </c:pt>
              </c:strCache>
            </c:strRef>
          </c:tx>
          <c:spPr>
            <a:ln w="28575">
              <a:noFill/>
            </a:ln>
          </c:spPr>
          <c:marker>
            <c:symbol val="plus"/>
            <c:size val="7"/>
            <c:spPr>
              <a:ln w="15875">
                <a:solidFill>
                  <a:srgbClr val="3399FF"/>
                </a:solidFill>
              </a:ln>
            </c:spPr>
          </c:marker>
          <c:xVal>
            <c:numRef>
              <c:f>'Ho-intraASD-FROH'!$D$89:$D$113</c:f>
              <c:numCache>
                <c:formatCode>General</c:formatCode>
                <c:ptCount val="25"/>
                <c:pt idx="0">
                  <c:v>0.13501229268042061</c:v>
                </c:pt>
                <c:pt idx="1">
                  <c:v>0.35667789025266888</c:v>
                </c:pt>
                <c:pt idx="2">
                  <c:v>0.35996200000000039</c:v>
                </c:pt>
                <c:pt idx="3">
                  <c:v>0.32683294998126189</c:v>
                </c:pt>
                <c:pt idx="4">
                  <c:v>0.34638415963299962</c:v>
                </c:pt>
                <c:pt idx="5">
                  <c:v>0.29447658564112161</c:v>
                </c:pt>
                <c:pt idx="6">
                  <c:v>0.33477954683696481</c:v>
                </c:pt>
                <c:pt idx="7">
                  <c:v>0.38829771443471889</c:v>
                </c:pt>
                <c:pt idx="8">
                  <c:v>0.39408259354910641</c:v>
                </c:pt>
                <c:pt idx="9">
                  <c:v>0.39759494372372567</c:v>
                </c:pt>
                <c:pt idx="10">
                  <c:v>0.41380549554471541</c:v>
                </c:pt>
                <c:pt idx="11">
                  <c:v>0.35868617107633677</c:v>
                </c:pt>
                <c:pt idx="12">
                  <c:v>0.39699473599044777</c:v>
                </c:pt>
                <c:pt idx="13">
                  <c:v>0.39963908791745839</c:v>
                </c:pt>
                <c:pt idx="14">
                  <c:v>0.37775734446918863</c:v>
                </c:pt>
                <c:pt idx="15">
                  <c:v>0.36084015521063095</c:v>
                </c:pt>
                <c:pt idx="16">
                  <c:v>0.37485645348417945</c:v>
                </c:pt>
                <c:pt idx="17">
                  <c:v>0.38286303334590077</c:v>
                </c:pt>
                <c:pt idx="18">
                  <c:v>0.27737569490767516</c:v>
                </c:pt>
                <c:pt idx="19">
                  <c:v>0.3939039069854039</c:v>
                </c:pt>
                <c:pt idx="20">
                  <c:v>0.28104852571080235</c:v>
                </c:pt>
                <c:pt idx="21">
                  <c:v>0.24278978225705444</c:v>
                </c:pt>
                <c:pt idx="22">
                  <c:v>0.25676178777038861</c:v>
                </c:pt>
                <c:pt idx="23">
                  <c:v>0.30712615947685717</c:v>
                </c:pt>
                <c:pt idx="24">
                  <c:v>0.3245195319846696</c:v>
                </c:pt>
              </c:numCache>
            </c:numRef>
          </c:xVal>
          <c:yVal>
            <c:numRef>
              <c:f>'Ho-intraASD-FROH'!$F$89:$F$113</c:f>
              <c:numCache>
                <c:formatCode>General</c:formatCode>
                <c:ptCount val="25"/>
                <c:pt idx="10" formatCode="00,000">
                  <c:v>1.9162162998437631E-2</c:v>
                </c:pt>
                <c:pt idx="11" formatCode="00,000">
                  <c:v>0.14818679850214</c:v>
                </c:pt>
                <c:pt idx="12" formatCode="00,000">
                  <c:v>3.8198898041503004E-2</c:v>
                </c:pt>
                <c:pt idx="13" formatCode="00,000">
                  <c:v>3.9613222531681876E-2</c:v>
                </c:pt>
                <c:pt idx="14" formatCode="00,000">
                  <c:v>0.11720498305142321</c:v>
                </c:pt>
                <c:pt idx="15" formatCode="00,000">
                  <c:v>0.13640840287118203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1-6B6B-4D59-B74E-EF2D32C92F04}"/>
            </c:ext>
          </c:extLst>
        </c:ser>
        <c:ser>
          <c:idx val="2"/>
          <c:order val="2"/>
          <c:tx>
            <c:strRef>
              <c:f>'Ho-intraASD-FROH'!$G$88</c:f>
              <c:strCache>
                <c:ptCount val="1"/>
                <c:pt idx="0">
                  <c:v>Nordic</c:v>
                </c:pt>
              </c:strCache>
            </c:strRef>
          </c:tx>
          <c:spPr>
            <a:ln w="28575">
              <a:noFill/>
            </a:ln>
          </c:spPr>
          <c:marker>
            <c:symbol val="x"/>
            <c:size val="7"/>
            <c:spPr>
              <a:noFill/>
              <a:ln w="15875">
                <a:solidFill>
                  <a:srgbClr val="0000FF"/>
                </a:solidFill>
              </a:ln>
            </c:spPr>
          </c:marker>
          <c:xVal>
            <c:numRef>
              <c:f>'Ho-intraASD-FROH'!$D$89:$D$113</c:f>
              <c:numCache>
                <c:formatCode>General</c:formatCode>
                <c:ptCount val="25"/>
                <c:pt idx="0">
                  <c:v>0.13501229268042061</c:v>
                </c:pt>
                <c:pt idx="1">
                  <c:v>0.35667789025266888</c:v>
                </c:pt>
                <c:pt idx="2">
                  <c:v>0.35996200000000039</c:v>
                </c:pt>
                <c:pt idx="3">
                  <c:v>0.32683294998126189</c:v>
                </c:pt>
                <c:pt idx="4">
                  <c:v>0.34638415963299962</c:v>
                </c:pt>
                <c:pt idx="5">
                  <c:v>0.29447658564112161</c:v>
                </c:pt>
                <c:pt idx="6">
                  <c:v>0.33477954683696481</c:v>
                </c:pt>
                <c:pt idx="7">
                  <c:v>0.38829771443471889</c:v>
                </c:pt>
                <c:pt idx="8">
                  <c:v>0.39408259354910641</c:v>
                </c:pt>
                <c:pt idx="9">
                  <c:v>0.39759494372372567</c:v>
                </c:pt>
                <c:pt idx="10">
                  <c:v>0.41380549554471541</c:v>
                </c:pt>
                <c:pt idx="11">
                  <c:v>0.35868617107633677</c:v>
                </c:pt>
                <c:pt idx="12">
                  <c:v>0.39699473599044777</c:v>
                </c:pt>
                <c:pt idx="13">
                  <c:v>0.39963908791745839</c:v>
                </c:pt>
                <c:pt idx="14">
                  <c:v>0.37775734446918863</c:v>
                </c:pt>
                <c:pt idx="15">
                  <c:v>0.36084015521063095</c:v>
                </c:pt>
                <c:pt idx="16">
                  <c:v>0.37485645348417945</c:v>
                </c:pt>
                <c:pt idx="17">
                  <c:v>0.38286303334590077</c:v>
                </c:pt>
                <c:pt idx="18">
                  <c:v>0.27737569490767516</c:v>
                </c:pt>
                <c:pt idx="19">
                  <c:v>0.3939039069854039</c:v>
                </c:pt>
                <c:pt idx="20">
                  <c:v>0.28104852571080235</c:v>
                </c:pt>
                <c:pt idx="21">
                  <c:v>0.24278978225705444</c:v>
                </c:pt>
                <c:pt idx="22">
                  <c:v>0.25676178777038861</c:v>
                </c:pt>
                <c:pt idx="23">
                  <c:v>0.30712615947685717</c:v>
                </c:pt>
                <c:pt idx="24">
                  <c:v>0.3245195319846696</c:v>
                </c:pt>
              </c:numCache>
            </c:numRef>
          </c:xVal>
          <c:yVal>
            <c:numRef>
              <c:f>'Ho-intraASD-FROH'!$G$89:$G$113</c:f>
              <c:numCache>
                <c:formatCode>00,000</c:formatCode>
                <c:ptCount val="25"/>
                <c:pt idx="1">
                  <c:v>9.1894199755451558E-2</c:v>
                </c:pt>
                <c:pt idx="2">
                  <c:v>0.16351222573466473</c:v>
                </c:pt>
                <c:pt idx="3">
                  <c:v>0.25375931828000814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2-6B6B-4D59-B74E-EF2D32C92F04}"/>
            </c:ext>
          </c:extLst>
        </c:ser>
        <c:ser>
          <c:idx val="3"/>
          <c:order val="3"/>
          <c:tx>
            <c:strRef>
              <c:f>'Ho-intraASD-FROH'!$H$88</c:f>
              <c:strCache>
                <c:ptCount val="1"/>
                <c:pt idx="0">
                  <c:v>Continental</c:v>
                </c:pt>
              </c:strCache>
            </c:strRef>
          </c:tx>
          <c:spPr>
            <a:ln w="28575">
              <a:noFill/>
            </a:ln>
          </c:spPr>
          <c:marker>
            <c:symbol val="x"/>
            <c:size val="6"/>
            <c:spPr>
              <a:noFill/>
              <a:ln w="15875">
                <a:solidFill>
                  <a:srgbClr val="FF7C80"/>
                </a:solidFill>
              </a:ln>
            </c:spPr>
          </c:marker>
          <c:xVal>
            <c:numRef>
              <c:f>'Ho-intraASD-FROH'!$D$89:$D$113</c:f>
              <c:numCache>
                <c:formatCode>General</c:formatCode>
                <c:ptCount val="25"/>
                <c:pt idx="0">
                  <c:v>0.13501229268042061</c:v>
                </c:pt>
                <c:pt idx="1">
                  <c:v>0.35667789025266888</c:v>
                </c:pt>
                <c:pt idx="2">
                  <c:v>0.35996200000000039</c:v>
                </c:pt>
                <c:pt idx="3">
                  <c:v>0.32683294998126189</c:v>
                </c:pt>
                <c:pt idx="4">
                  <c:v>0.34638415963299962</c:v>
                </c:pt>
                <c:pt idx="5">
                  <c:v>0.29447658564112161</c:v>
                </c:pt>
                <c:pt idx="6">
                  <c:v>0.33477954683696481</c:v>
                </c:pt>
                <c:pt idx="7">
                  <c:v>0.38829771443471889</c:v>
                </c:pt>
                <c:pt idx="8">
                  <c:v>0.39408259354910641</c:v>
                </c:pt>
                <c:pt idx="9">
                  <c:v>0.39759494372372567</c:v>
                </c:pt>
                <c:pt idx="10">
                  <c:v>0.41380549554471541</c:v>
                </c:pt>
                <c:pt idx="11">
                  <c:v>0.35868617107633677</c:v>
                </c:pt>
                <c:pt idx="12">
                  <c:v>0.39699473599044777</c:v>
                </c:pt>
                <c:pt idx="13">
                  <c:v>0.39963908791745839</c:v>
                </c:pt>
                <c:pt idx="14">
                  <c:v>0.37775734446918863</c:v>
                </c:pt>
                <c:pt idx="15">
                  <c:v>0.36084015521063095</c:v>
                </c:pt>
                <c:pt idx="16">
                  <c:v>0.37485645348417945</c:v>
                </c:pt>
                <c:pt idx="17">
                  <c:v>0.38286303334590077</c:v>
                </c:pt>
                <c:pt idx="18">
                  <c:v>0.27737569490767516</c:v>
                </c:pt>
                <c:pt idx="19">
                  <c:v>0.3939039069854039</c:v>
                </c:pt>
                <c:pt idx="20">
                  <c:v>0.28104852571080235</c:v>
                </c:pt>
                <c:pt idx="21">
                  <c:v>0.24278978225705444</c:v>
                </c:pt>
                <c:pt idx="22">
                  <c:v>0.25676178777038861</c:v>
                </c:pt>
                <c:pt idx="23">
                  <c:v>0.30712615947685717</c:v>
                </c:pt>
                <c:pt idx="24">
                  <c:v>0.3245195319846696</c:v>
                </c:pt>
              </c:numCache>
            </c:numRef>
          </c:xVal>
          <c:yVal>
            <c:numRef>
              <c:f>'Ho-intraASD-FROH'!$H$89:$H$113</c:f>
              <c:numCache>
                <c:formatCode>General</c:formatCode>
                <c:ptCount val="25"/>
                <c:pt idx="7" formatCode="00,000">
                  <c:v>8.897486937028766E-2</c:v>
                </c:pt>
                <c:pt idx="8" formatCode="00,000">
                  <c:v>6.3335891557978433E-2</c:v>
                </c:pt>
                <c:pt idx="9" formatCode="00,000">
                  <c:v>5.5044738962086101E-2</c:v>
                </c:pt>
                <c:pt idx="16" formatCode="00,000">
                  <c:v>0.10048886217648258</c:v>
                </c:pt>
                <c:pt idx="17" formatCode="00,000">
                  <c:v>6.1555643814958233E-2</c:v>
                </c:pt>
                <c:pt idx="19" formatCode="00,000">
                  <c:v>5.9650246234507293E-2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3-6B6B-4D59-B74E-EF2D32C92F04}"/>
            </c:ext>
          </c:extLst>
        </c:ser>
        <c:axId val="55341056"/>
        <c:axId val="55343360"/>
      </c:scatterChart>
      <c:valAx>
        <c:axId val="55341056"/>
        <c:scaling>
          <c:orientation val="minMax"/>
          <c:min val="0.1"/>
        </c:scaling>
        <c:axPos val="b"/>
        <c:title>
          <c:tx>
            <c:rich>
              <a:bodyPr/>
              <a:lstStyle/>
              <a:p>
                <a:pPr>
                  <a:defRPr sz="1200" b="0" baseline="0"/>
                </a:pPr>
                <a:r>
                  <a:rPr lang="nl-NL" sz="1200" b="0" baseline="0"/>
                  <a:t>Observed heterozygosity</a:t>
                </a:r>
              </a:p>
            </c:rich>
          </c:tx>
          <c:layout>
            <c:manualLayout>
              <c:xMode val="edge"/>
              <c:yMode val="edge"/>
              <c:x val="0.324294471681221"/>
              <c:y val="0.86989207818671277"/>
            </c:manualLayout>
          </c:layout>
        </c:title>
        <c:numFmt formatCode="General" sourceLinked="1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1200" baseline="0"/>
            </a:pPr>
            <a:endParaRPr lang="es-ES"/>
          </a:p>
        </c:txPr>
        <c:crossAx val="55343360"/>
        <c:crosses val="autoZero"/>
        <c:crossBetween val="midCat"/>
        <c:majorUnit val="0.1"/>
      </c:valAx>
      <c:valAx>
        <c:axId val="55343360"/>
        <c:scaling>
          <c:orientation val="minMax"/>
          <c:max val="0.70000000000000062"/>
          <c:min val="0"/>
        </c:scaling>
        <c:axPos val="l"/>
        <c:majorGridlines>
          <c:spPr>
            <a:ln>
              <a:noFill/>
            </a:ln>
          </c:spPr>
        </c:majorGridlines>
        <c:title>
          <c:tx>
            <c:rich>
              <a:bodyPr/>
              <a:lstStyle/>
              <a:p>
                <a:pPr>
                  <a:defRPr sz="1200" b="0" baseline="0"/>
                </a:pPr>
                <a:r>
                  <a:rPr lang="nl-NL" sz="1200" b="0" i="0" baseline="0" dirty="0"/>
                  <a:t>F</a:t>
                </a:r>
                <a:r>
                  <a:rPr lang="nl-NL" sz="1200" b="0" i="0" baseline="-25000" dirty="0"/>
                  <a:t>ROH</a:t>
                </a:r>
              </a:p>
            </c:rich>
          </c:tx>
          <c:layout>
            <c:manualLayout>
              <c:xMode val="edge"/>
              <c:yMode val="edge"/>
              <c:x val="7.9942375830313134E-2"/>
              <c:y val="0.32589603615841983"/>
            </c:manualLayout>
          </c:layout>
        </c:title>
        <c:numFmt formatCode="0.0" sourceLinked="0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1200" baseline="0"/>
            </a:pPr>
            <a:endParaRPr lang="es-ES"/>
          </a:p>
        </c:txPr>
        <c:crossAx val="55341056"/>
        <c:crosses val="autoZero"/>
        <c:crossBetween val="midCat"/>
      </c:valAx>
      <c:spPr>
        <a:ln>
          <a:solidFill>
            <a:sysClr val="windowText" lastClr="000000"/>
          </a:solidFill>
        </a:ln>
      </c:spPr>
    </c:plotArea>
    <c:legend>
      <c:legendPos val="r"/>
      <c:layout>
        <c:manualLayout>
          <c:xMode val="edge"/>
          <c:yMode val="edge"/>
          <c:x val="0.43200550878946176"/>
          <c:y val="5.446101984855737E-2"/>
          <c:w val="0.36297772124273664"/>
          <c:h val="0.23617672790901112"/>
        </c:manualLayout>
      </c:layout>
      <c:spPr>
        <a:ln>
          <a:solidFill>
            <a:schemeClr val="tx1"/>
          </a:solidFill>
        </a:ln>
      </c:spPr>
      <c:txPr>
        <a:bodyPr/>
        <a:lstStyle/>
        <a:p>
          <a:pPr>
            <a:defRPr sz="1050" baseline="0"/>
          </a:pPr>
          <a:endParaRPr lang="es-ES"/>
        </a:p>
      </c:txPr>
    </c:legend>
    <c:plotVisOnly val="1"/>
    <c:dispBlanksAs val="gap"/>
  </c:chart>
  <c:spPr>
    <a:ln>
      <a:noFill/>
    </a:ln>
  </c:spPr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D0760E8-78E5-4658-8E19-334070D699C6}" type="datetimeFigureOut">
              <a:rPr lang="es-ES"/>
              <a:pPr>
                <a:defRPr/>
              </a:pPr>
              <a:t>04/05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71CDF9E-0F75-438C-B2B0-744F232B29CC}" type="slidenum">
              <a:rPr lang="es-ES"/>
              <a:pPr>
                <a:defRPr/>
              </a:pPr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92643F8-0D31-4C90-BA1A-776C44CB696D}" type="datetimeFigureOut">
              <a:rPr lang="es-ES"/>
              <a:pPr>
                <a:defRPr/>
              </a:pPr>
              <a:t>04/05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9BC6D4D-648B-45DD-8E59-BBB12F616214}" type="slidenum">
              <a:rPr lang="es-ES"/>
              <a:pPr>
                <a:defRPr/>
              </a:pPr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A997515-BE02-43AA-84C3-E379B99736EB}" type="datetimeFigureOut">
              <a:rPr lang="es-ES"/>
              <a:pPr>
                <a:defRPr/>
              </a:pPr>
              <a:t>04/05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DCB30D6-7E0E-4381-9E0E-0D7056E17181}" type="slidenum">
              <a:rPr lang="es-ES"/>
              <a:pPr>
                <a:defRPr/>
              </a:pPr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CCF1156-9000-4D0A-A37C-8BBD10AFAC4D}" type="datetimeFigureOut">
              <a:rPr lang="es-ES"/>
              <a:pPr>
                <a:defRPr/>
              </a:pPr>
              <a:t>04/05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3482963-8136-410E-9DBB-4E95927F382A}" type="slidenum">
              <a:rPr lang="es-ES"/>
              <a:pPr>
                <a:defRPr/>
              </a:pPr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9445279-4348-49B9-9DE6-64576FAA5A60}" type="datetimeFigureOut">
              <a:rPr lang="es-ES"/>
              <a:pPr>
                <a:defRPr/>
              </a:pPr>
              <a:t>04/05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61D3067-1350-4AF4-AE3C-551EAA1712D6}" type="slidenum">
              <a:rPr lang="es-ES"/>
              <a:pPr>
                <a:defRPr/>
              </a:pPr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9F4B973-9401-4BB1-B55E-A0620932F8BD}" type="datetimeFigureOut">
              <a:rPr lang="es-ES"/>
              <a:pPr>
                <a:defRPr/>
              </a:pPr>
              <a:t>04/05/2018</a:t>
            </a:fld>
            <a:endParaRPr lang="es-ES"/>
          </a:p>
        </p:txBody>
      </p:sp>
      <p:sp>
        <p:nvSpPr>
          <p:cNvPr id="6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A10906-6F50-413C-97A8-8E6317C2A250}" type="slidenum">
              <a:rPr lang="es-ES"/>
              <a:pPr>
                <a:defRPr/>
              </a:pPr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4186BFE-E920-46E3-A746-E213F73CD264}" type="datetimeFigureOut">
              <a:rPr lang="es-ES"/>
              <a:pPr>
                <a:defRPr/>
              </a:pPr>
              <a:t>04/05/2018</a:t>
            </a:fld>
            <a:endParaRPr lang="es-ES"/>
          </a:p>
        </p:txBody>
      </p:sp>
      <p:sp>
        <p:nvSpPr>
          <p:cNvPr id="8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9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B74663B-2BF2-4EAB-A974-FEDF583C7D59}" type="slidenum">
              <a:rPr lang="es-ES"/>
              <a:pPr>
                <a:defRPr/>
              </a:pPr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07C45D5-48C6-4C7F-853E-E602840BE44A}" type="datetimeFigureOut">
              <a:rPr lang="es-ES"/>
              <a:pPr>
                <a:defRPr/>
              </a:pPr>
              <a:t>04/05/2018</a:t>
            </a:fld>
            <a:endParaRPr lang="es-ES"/>
          </a:p>
        </p:txBody>
      </p:sp>
      <p:sp>
        <p:nvSpPr>
          <p:cNvPr id="4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5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E6CE5F9-8D04-4AEB-A599-6AC5E8E4B7DC}" type="slidenum">
              <a:rPr lang="es-ES"/>
              <a:pPr>
                <a:defRPr/>
              </a:pPr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E09C9F-77F2-4161-9ACA-C7CB7A2F6671}" type="datetimeFigureOut">
              <a:rPr lang="es-ES"/>
              <a:pPr>
                <a:defRPr/>
              </a:pPr>
              <a:t>04/05/2018</a:t>
            </a:fld>
            <a:endParaRPr lang="es-ES"/>
          </a:p>
        </p:txBody>
      </p:sp>
      <p:sp>
        <p:nvSpPr>
          <p:cNvPr id="3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4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111666F-56AE-496D-84B0-AD68A8FE1B8C}" type="slidenum">
              <a:rPr lang="es-ES"/>
              <a:pPr>
                <a:defRPr/>
              </a:pPr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69639EF-2B8C-4BCD-A23D-516E2C79320E}" type="datetimeFigureOut">
              <a:rPr lang="es-ES"/>
              <a:pPr>
                <a:defRPr/>
              </a:pPr>
              <a:t>04/05/2018</a:t>
            </a:fld>
            <a:endParaRPr lang="es-ES"/>
          </a:p>
        </p:txBody>
      </p:sp>
      <p:sp>
        <p:nvSpPr>
          <p:cNvPr id="6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4DEA4B-E2B8-4980-A0D5-C6E998D22C79}" type="slidenum">
              <a:rPr lang="es-ES"/>
              <a:pPr>
                <a:defRPr/>
              </a:pPr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s-ES" noProof="0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51B1762-D9A9-4D0E-A820-6D5E5EB37CA4}" type="datetimeFigureOut">
              <a:rPr lang="es-ES"/>
              <a:pPr>
                <a:defRPr/>
              </a:pPr>
              <a:t>04/05/2018</a:t>
            </a:fld>
            <a:endParaRPr lang="es-ES"/>
          </a:p>
        </p:txBody>
      </p:sp>
      <p:sp>
        <p:nvSpPr>
          <p:cNvPr id="6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B2027E2-FF3C-4800-A185-81E0653EAB13}" type="slidenum">
              <a:rPr lang="es-ES"/>
              <a:pPr>
                <a:defRPr/>
              </a:pPr>
              <a:t>‹#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1 Marcador de título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s-ES" smtClean="0"/>
              <a:t>Haga clic para modificar el estilo de título del patrón</a:t>
            </a:r>
          </a:p>
        </p:txBody>
      </p:sp>
      <p:sp>
        <p:nvSpPr>
          <p:cNvPr id="1027" name="2 Marcador de texto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EDE6E90A-DC50-4391-9DEA-8596DF80FDD4}" type="datetimeFigureOut">
              <a:rPr lang="es-ES"/>
              <a:pPr>
                <a:defRPr/>
              </a:pPr>
              <a:t>04/05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BBA7876F-7891-4A4D-900F-5E141E9A75CE}" type="slidenum">
              <a:rPr lang="es-ES"/>
              <a:pPr>
                <a:defRPr/>
              </a:pPr>
              <a:t>‹#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3" name="1 Rectángulo"/>
          <p:cNvSpPr>
            <a:spLocks noChangeArrowheads="1"/>
          </p:cNvSpPr>
          <p:nvPr/>
        </p:nvSpPr>
        <p:spPr bwMode="auto">
          <a:xfrm>
            <a:off x="395288" y="333375"/>
            <a:ext cx="8208962" cy="641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b="1"/>
              <a:t>Figure S3. </a:t>
            </a:r>
            <a:r>
              <a:rPr lang="en-US"/>
              <a:t>Relationship between observed heterozygosity </a:t>
            </a:r>
            <a:r>
              <a:rPr lang="en-US" i="1"/>
              <a:t>vs.</a:t>
            </a:r>
            <a:r>
              <a:rPr lang="en-US"/>
              <a:t> (left) ROH coverage or (right) within-population allele-sharing distances.</a:t>
            </a:r>
            <a:r>
              <a:rPr lang="es-ES"/>
              <a:t> </a:t>
            </a:r>
            <a:r>
              <a:rPr lang="en-US">
                <a:latin typeface="Calibri" pitchFamily="34" charset="0"/>
              </a:rPr>
              <a:t> </a:t>
            </a:r>
            <a:endParaRPr lang="es-ES">
              <a:latin typeface="Calibri" pitchFamily="34" charset="0"/>
            </a:endParaRPr>
          </a:p>
        </p:txBody>
      </p:sp>
      <p:graphicFrame>
        <p:nvGraphicFramePr>
          <p:cNvPr id="120" name="Chart 118">
            <a:extLst>
              <a:ext uri="{FF2B5EF4-FFF2-40B4-BE49-F238E27FC236}"/>
            </a:extLst>
          </p:cNvPr>
          <p:cNvGraphicFramePr>
            <a:graphicFrameLocks/>
          </p:cNvGraphicFramePr>
          <p:nvPr/>
        </p:nvGraphicFramePr>
        <p:xfrm>
          <a:off x="683568" y="1628800"/>
          <a:ext cx="3333750" cy="3238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21" name="Chart 119">
            <a:extLst>
              <a:ext uri="{FF2B5EF4-FFF2-40B4-BE49-F238E27FC236}"/>
            </a:extLst>
          </p:cNvPr>
          <p:cNvGraphicFramePr>
            <a:graphicFrameLocks/>
          </p:cNvGraphicFramePr>
          <p:nvPr/>
        </p:nvGraphicFramePr>
        <p:xfrm>
          <a:off x="4355976" y="1844824"/>
          <a:ext cx="3888432" cy="29813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5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2</vt:i4>
      </vt:variant>
      <vt:variant>
        <vt:lpstr>Plantilla de diseño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4" baseType="lpstr">
      <vt:lpstr>Calibri</vt:lpstr>
      <vt:lpstr>Arial</vt:lpstr>
      <vt:lpstr>Tema de Office</vt:lpstr>
      <vt:lpstr>Diapositiva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tfigueiredo</dc:creator>
  <cp:lastModifiedBy>marcel</cp:lastModifiedBy>
  <cp:revision>8</cp:revision>
  <dcterms:created xsi:type="dcterms:W3CDTF">2018-04-09T13:53:35Z</dcterms:created>
  <dcterms:modified xsi:type="dcterms:W3CDTF">2018-05-04T20:57:22Z</dcterms:modified>
</cp:coreProperties>
</file>